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12" autoAdjust="0"/>
    <p:restoredTop sz="67047" autoAdjust="0"/>
  </p:normalViewPr>
  <p:slideViewPr>
    <p:cSldViewPr snapToGrid="0">
      <p:cViewPr>
        <p:scale>
          <a:sx n="50" d="100"/>
          <a:sy n="50" d="100"/>
        </p:scale>
        <p:origin x="2213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A127A6-CF15-4F68-B564-9F0066A53885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371287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7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A2E0E7-614E-4E60-B59F-60506C0C95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9036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A2E0E7-614E-4E60-B59F-60506C0C950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00569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591E2D-F5F7-4428-8397-DA1B8C5BCA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88FDE9B-3B05-48F2-92C8-BFDE1B1C97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71361C-1DFE-4687-9E70-5348B2B29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DEB01F-2424-43E6-A569-02A8B92AF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A68C57-28CF-4301-A3CF-EF092E98A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0744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C7BACF-E936-4DB0-A9A5-09B184F3D3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B830C8-D1F0-4272-878A-2BA18D62C2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25FA0F-3D00-4F7B-B775-17503E2FC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A455B5-1547-4153-AF94-406B0A7C5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194293-85C9-4283-9A6E-902775169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070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0DE38FF-D6FD-480D-AA15-F9F17B5E02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7EE9523-ABF4-4C15-AE19-531427DF6C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490EB9-05FA-4465-85FF-E55836262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3FC64B-37BB-4263-A808-CA710D2D2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FB568B-087D-4993-AC55-6E497AFD7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447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A8007B-E614-4577-B959-4C13A9D8F8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66225C6-4B6B-4BA8-B642-2D35317A2E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23C91F-B6B6-4A2B-98BD-C7501854E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94367A-D635-4A35-9D39-F6D85793A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46E004-287D-4ECF-BEC7-7BF212348A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462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6B15C8-1370-465A-8C0C-8747B5552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25B38E-C29D-4AFC-9CC8-E9CF0E063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E0B8DC-AE46-4441-A0B3-B5DCE97C2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42C729-E10C-44E0-AB87-8C0FE793E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B2B9CC-3F2E-4D51-BEE9-4EE2C7441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7581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233A23-B1C4-4DFE-B185-225BF4B7E5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75E954-31E8-4C7F-BBAC-6E6FCB9B44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D115DC2-4C13-4DCB-BDFA-C8B753B780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CBA91B-5E1F-4EF9-9E26-E36BAA2E5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B9CA4B-1BE3-4C6F-91F8-DE123B4BB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CEA7AE0-DB5A-45B0-8E51-6BB29A98B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555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615A47-CF83-4DC9-9EEB-D6791FCFC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E4C6739-1F0D-44EE-8935-30D7472743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C1B93DB-7660-4D92-AFE6-F7C43CC54D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9E5C88F-4E34-46BA-8DD6-1218D80667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C33B7CE-1C74-4D4C-809D-1A8788E7CD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F8B8D09-5BAA-42AE-920A-D699674B5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7C6B98B-9A11-400E-A4FA-99CCE711C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E6FB8D9-C157-43DE-B3C9-27B5F18A6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3556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21D466-7339-4AE2-8053-7DCE535B2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2360BE3-FA22-4226-8282-AD95FCB62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F7EAD93-19D1-4824-92A5-EB9690085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555CF0A-5CC9-42EC-87CB-FC856A5EB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629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40CCEF4-1FC9-4CF5-90FE-046A910FC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DA3DD73-92DE-45F3-BC13-3AFCDC113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4B3BA35-5F1F-480A-8566-48A11F7E1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365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08BC96-973E-44AD-A1FF-6C4932E0E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9D3C3E-21D2-4521-9731-254DCB1F4E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CE1FD2E-8396-4277-81A9-F0C329C6C4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1AE2E09-1A0E-4119-8883-FCAD08DD8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9A818D6-9EA1-496F-9E16-3ACF4B34F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B596CD6-2DD5-4DA2-AAEC-E6C11174E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934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FEA24D-7984-4EB8-A833-E6B07B739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E2524DC-5880-4B8D-B9FA-74E894A40D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C8157C-434F-4EFB-9E5E-8DB402881E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32921E-B7D8-40A7-B329-10146E987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CF0BA5-B85D-4C9B-B7FD-38761B357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C954D0-8E62-42D4-B4C5-0A2B45C98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766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39EBAA5-6FD1-4760-AE76-65FC789E7B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0A3BFD5-2FB3-4679-AC53-A895C8EC4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2B8DC8-2BA7-4E58-B35B-EDBA16811D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E24D7B-7306-4BEE-9F76-7B6299CB49BE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DBB1F9-A93C-4566-A4A4-D95F2FEF04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C73A2F-34AD-42A8-B485-E619A7788B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AB703-BE55-46BF-A752-3A3BA3E3F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196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CEA830E-1FCF-43A4-80C8-D168EED034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31930" y="383867"/>
            <a:ext cx="7260070" cy="502363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19890A6B-78F5-4F7E-8ADA-D351E6FBD3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3661" y="736619"/>
            <a:ext cx="4492554" cy="4452347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74348F8-D511-4CC3-838A-974D30707256}"/>
              </a:ext>
            </a:extLst>
          </p:cNvPr>
          <p:cNvSpPr txBox="1"/>
          <p:nvPr/>
        </p:nvSpPr>
        <p:spPr>
          <a:xfrm>
            <a:off x="445406" y="59331"/>
            <a:ext cx="4589064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itchFamily="34" charset="0"/>
                <a:cs typeface="Arial" pitchFamily="34" charset="0"/>
              </a:rPr>
              <a:t>Supplementary Figure 1</a:t>
            </a:r>
            <a:endParaRPr kumimoji="1" lang="ja-JP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1FB85A5-BE36-411D-A2DA-97BC35E88054}"/>
              </a:ext>
            </a:extLst>
          </p:cNvPr>
          <p:cNvSpPr txBox="1"/>
          <p:nvPr/>
        </p:nvSpPr>
        <p:spPr>
          <a:xfrm>
            <a:off x="6604761" y="805578"/>
            <a:ext cx="37494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hospholipid composition of PC</a:t>
            </a:r>
            <a:endParaRPr lang="ja-JP" altLang="en-US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E6D3B2A-38CA-7834-C8A6-F9AA5B518BD6}"/>
              </a:ext>
            </a:extLst>
          </p:cNvPr>
          <p:cNvSpPr txBox="1"/>
          <p:nvPr/>
        </p:nvSpPr>
        <p:spPr>
          <a:xfrm>
            <a:off x="6267433" y="52553"/>
            <a:ext cx="4589064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itchFamily="34" charset="0"/>
                <a:cs typeface="Arial" pitchFamily="34" charset="0"/>
              </a:rPr>
              <a:t>Supplementary Figure 2</a:t>
            </a:r>
            <a:endParaRPr kumimoji="1" lang="ja-JP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37FBF8B-37C1-43EC-BA9E-786D6B146550}"/>
              </a:ext>
            </a:extLst>
          </p:cNvPr>
          <p:cNvSpPr txBox="1"/>
          <p:nvPr/>
        </p:nvSpPr>
        <p:spPr>
          <a:xfrm>
            <a:off x="115747" y="5373105"/>
            <a:ext cx="12076253" cy="138499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: C2C12 cells were plated in 6-well plates at 2.0 × 10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 well and cultured in DMEM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2: C2C12 cells were plated in 6-well plates at 2.0 × 10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 well and cultured in DMEM with 300 ng/ml human recombinant BMP2.</a:t>
            </a:r>
          </a:p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ntrol and si-LPCAT2: C2C12 cells were transfected with 100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NAs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ntrol or si-LPCAT2) for 24 h. The cells were further cultured in DMEM containing 300 ng/ml human recombinant BMP2 for 7 days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Lysophosphatidylcholine acyltransferase (LPCAT) activity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Phospholipid composition of phosphocholine (PC)  </a:t>
            </a:r>
          </a:p>
          <a:p>
            <a:r>
              <a:rPr lang="en-GB" altLang="ja-JP" sz="1200" dirty="0" err="1">
                <a:solidFill>
                  <a:srgbClr val="201F1E"/>
                </a:solidFill>
                <a:effectLst/>
                <a:latin typeface="Times New Roman" panose="02020603050405020304" pitchFamily="18" charset="0"/>
                <a:ea typeface="Yu Gothic UI" panose="020B0500000000000000" pitchFamily="50" charset="-128"/>
              </a:rPr>
              <a:t>ePC</a:t>
            </a:r>
            <a:r>
              <a:rPr lang="en-GB" altLang="ja-JP" sz="1200" dirty="0">
                <a:solidFill>
                  <a:srgbClr val="201F1E"/>
                </a:solidFill>
                <a:effectLst/>
                <a:latin typeface="Times New Roman" panose="02020603050405020304" pitchFamily="18" charset="0"/>
                <a:ea typeface="Yu Gothic UI" panose="020B0500000000000000" pitchFamily="50" charset="-128"/>
              </a:rPr>
              <a:t> = alkenyl-PC, </a:t>
            </a:r>
            <a:r>
              <a:rPr lang="en-GB" altLang="ja-JP" sz="1200" dirty="0" err="1">
                <a:solidFill>
                  <a:srgbClr val="201F1E"/>
                </a:solidFill>
                <a:effectLst/>
                <a:latin typeface="Times New Roman" panose="02020603050405020304" pitchFamily="18" charset="0"/>
                <a:ea typeface="Yu Gothic UI" panose="020B0500000000000000" pitchFamily="50" charset="-128"/>
              </a:rPr>
              <a:t>oPC</a:t>
            </a:r>
            <a:r>
              <a:rPr lang="en-GB" altLang="ja-JP" sz="1200" dirty="0">
                <a:solidFill>
                  <a:srgbClr val="201F1E"/>
                </a:solidFill>
                <a:effectLst/>
                <a:latin typeface="Times New Roman" panose="02020603050405020304" pitchFamily="18" charset="0"/>
                <a:ea typeface="Yu Gothic UI" panose="020B0500000000000000" pitchFamily="50" charset="-128"/>
              </a:rPr>
              <a:t> = alkyl-PC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0265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05</TotalTime>
  <Words>130</Words>
  <Application>Microsoft Office PowerPoint</Application>
  <PresentationFormat>ワイド画面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部 士郎</dc:creator>
  <cp:lastModifiedBy>士郎 田部</cp:lastModifiedBy>
  <cp:revision>102</cp:revision>
  <cp:lastPrinted>2019-04-02T10:14:43Z</cp:lastPrinted>
  <dcterms:created xsi:type="dcterms:W3CDTF">2018-11-16T06:24:50Z</dcterms:created>
  <dcterms:modified xsi:type="dcterms:W3CDTF">2024-05-18T05:08:59Z</dcterms:modified>
</cp:coreProperties>
</file>